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3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2" autoAdjust="0"/>
    <p:restoredTop sz="94660"/>
  </p:normalViewPr>
  <p:slideViewPr>
    <p:cSldViewPr snapToGrid="0">
      <p:cViewPr varScale="1">
        <p:scale>
          <a:sx n="89" d="100"/>
          <a:sy n="89" d="100"/>
        </p:scale>
        <p:origin x="2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6344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47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6376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034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7668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028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401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394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489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5506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3454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C31FB-9D1D-45CB-98B5-F19388D2EB91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CD63F-76E8-4B9E-BE90-4634F1D428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6127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4603" y="-5107"/>
            <a:ext cx="6803895" cy="66476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6558447"/>
            <a:ext cx="123712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irco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plot of the Express 617 genome assembly. The inner blue track represents the distribution of predicted transcripts and the following magenta track represents repetitive elements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1395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974" y="6257836"/>
            <a:ext cx="1202362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Exemplar GOGG results for allelic patterns of first 310 SNP markers in chromosome A01. For each marker (row), genotypes were colour-coded with allele (pink being A and blue being B). Red blocks at the right indicate five potential misassembled regions based on the discordance of allelic patterns with adjacent markers. Discordance of allelic patterns are potential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assemblie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s alternating parental alleles in individual recombinant lines are expected to be low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2224" y="0"/>
            <a:ext cx="3013214" cy="6266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2347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087107"/>
            <a:ext cx="1206630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Exemplar long read alignments showing true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join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Figure shows an IGV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creensho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long read alignments at the fifth red block region in Figure S2. Reads were sorted by mapping quality and coloured by strand. Alignments of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cBio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ong reads were shown in the upper panel and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nopor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reads were in the lower panel. As clear breakpoint was observed by a sharp decrease of read coverage and increase of variants in the reads that managed to align, this region was identified as a true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join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839" y="545610"/>
            <a:ext cx="11155680" cy="5362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56522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729" y="564462"/>
            <a:ext cx="10972800" cy="527494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0" y="6087107"/>
            <a:ext cx="1206630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Exemplar long read alignments showing falsely-recognised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assembly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Figure shows an IGV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creenshot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long read alignments at the fifth red block region in Figure S2. Reads were sorted by mapping quality and coloured by strand. Alignments of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cBio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ong reads were shown in the upper panel and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anopor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reads were in the lower panel. This region was identified as a false positive as no breakpoint was observed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33040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5691" y="6388641"/>
            <a:ext cx="1206630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Evaluation of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eudochromosomal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onstruction with physical versus genetic positions of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0K Illumin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nfiniu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rassica SNP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rray markers in three genetic maps. Genetic linkage groups were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coded. In several cases, the genetic positions were oriented in reverse of the chromosomal positions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766" y="10273"/>
            <a:ext cx="10254538" cy="64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96651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32068" y="626762"/>
            <a:ext cx="792381" cy="13495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25692" y="6255076"/>
            <a:ext cx="1177075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o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lot comparison between Express 617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) Brassica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p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genotype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ifu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lse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 2018), and b) Brassica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erace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genotype HDEM;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lse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 2018)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milarity i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olou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oded from 0 to 1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122" y="544531"/>
            <a:ext cx="5400000" cy="54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4449" y="544531"/>
            <a:ext cx="5472000" cy="5472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0068" y="365152"/>
            <a:ext cx="2573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158845" y="365152"/>
            <a:ext cx="25736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54837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1103" y="206013"/>
            <a:ext cx="7778201" cy="583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5691" y="6255076"/>
            <a:ext cx="1206630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. Evaluation of gene space completeness in Express 617 assembly compared to four other assemblies using BUSCO which identifies orthologous groups in the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assicale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lineage (total number of groups = 4596)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809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5</Words>
  <Application>Microsoft Office PowerPoint</Application>
  <PresentationFormat>Widescreen</PresentationFormat>
  <Paragraphs>1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L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Huey T</dc:creator>
  <cp:lastModifiedBy>Lee, Huey T</cp:lastModifiedBy>
  <cp:revision>45</cp:revision>
  <dcterms:created xsi:type="dcterms:W3CDTF">2019-10-04T09:08:10Z</dcterms:created>
  <dcterms:modified xsi:type="dcterms:W3CDTF">2020-03-10T09:47:50Z</dcterms:modified>
</cp:coreProperties>
</file>